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5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1012" y="9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80A2A1-CAC5-84D6-FB12-410FB0C3A89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5650DB2-E0BA-B038-084C-49FA2A79ED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7E9AF6-C6F0-2298-48B6-B58285257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D8A665-6899-4B44-6C8C-9BB652E25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AA94AF-2E33-C3AF-3A0E-425318F55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729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00942B-F8ED-3B0E-8A49-4CDA1276F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ACD54EC-FE2A-4F37-EBE2-864D9789FE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CA65B8-D3C5-B3E6-76C1-4416FCF01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781EB3-FBAB-76F6-A397-6BA28AD56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06B623-5169-88D4-7333-AEDB7B59C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336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4D03A69-1423-09BE-57A3-5654416FAF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2167764-23B4-0321-E3AE-356CC0FAC0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0EA97D-3DA7-F5EB-E068-E20A302AF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474267-2B2C-CF20-1FC9-C828D4252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1687D7-7C87-7274-A92B-EA805E750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7328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445E22-E292-E44F-C5D0-417B76D5D8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BCDFF5-CEC9-E519-670F-3B48B9171B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334632-3D4A-6CDB-66CC-E74BBD9DD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BAA652-FD3F-E816-4F9C-8A34C2BDE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96D1A6-50DF-1BEB-2DB8-24102C484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0901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E338C4-21B3-4553-0E01-575EF81023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97B347-BC91-B2EF-97D8-8500A3BB9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48CEFA-0D62-4F36-553A-B0680270A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F4C20B-7237-BF1A-8D58-9F15A5CE6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3BA552-5D73-3A69-38B5-D7F9AF0D5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471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2A8A45-50EE-79AA-798F-90D7C7CA3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4F344C-1A16-69C4-CB06-1B7D7A12780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C6C6132-0C48-768F-08C0-C4555E3DFD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B213AB-2F86-9B38-7FA5-45E4818E1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00BEAC-00C8-52CC-43D9-CC520652D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6DA8E4-C6B1-0D7B-B919-8AA298CC7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1900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25DC25-F7DC-0593-4DF9-F35F0B25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54F1C11-B4E4-47A6-7D8E-2EE07C45F0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4913712-581D-8211-CCA9-8DA464BC3E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20FDC3A-8361-F39D-942F-6A61025007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FB2A0F2-8E64-6B6A-97A4-8A13D38736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7F462EC-9586-6A5D-5DC8-3926EC339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CB4AAF7-859C-A274-0659-041125EA3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2A1C61D-2080-38B4-D614-5225F71F9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9662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375DA2-9B94-BEFF-DFD7-0E97DC2B3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274FDA3-276A-6451-128A-DB5A1D8A7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9EEEB77-2E41-4D5A-59AC-039377862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E9D8C0B-B0D5-7174-B407-D4C2E67B3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8712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92794B9-1A00-DA12-CD7E-759EF94FE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5D2869E-0679-48B9-E204-6B1669884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3833F66-9D00-387C-C894-E1A1947AE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49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C55450-9B95-C511-AE78-5F94FBBB6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F052A6F-D7ED-C1C1-FF8D-EB6977A6DD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34DC9A5-2612-FCF5-2243-B365E61320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D07C84-6710-28C2-3AF9-30BEB8F0F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9964FC1-9E22-6614-E223-A0E20AF65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4915C8-5EFC-2C13-702B-850AED9EF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661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D2AE49-63BE-E356-31D5-F3D9C84CA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1FD156E-F213-5C5C-7388-0C329D008D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15BF9B-F111-8684-F828-A37120097E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EE1696D-352C-2BDE-1437-054688A77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04FE323-B555-38A2-6455-35E159254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F5CB277-457B-0E4B-04C5-F7248B781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749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02D5165-E035-DC9E-1012-5BF1FD74D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B087F1-6F3A-1DAF-7A12-99DFB6A414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A3C6E5-F261-0ACA-D0D5-A85E6B3D4B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C8714-D61E-4457-9A8C-30AF4C6A92D5}" type="datetimeFigureOut">
              <a:rPr lang="zh-CN" altLang="en-US" smtClean="0"/>
              <a:t>2025/9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9DC4E2F-D3B7-903E-0437-F176BB806E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2E0C28-2AE3-397A-5595-0DF2B0747D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D5823-DCBF-4842-8E13-E97BA2096A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5125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48">
            <a:extLst>
              <a:ext uri="{FF2B5EF4-FFF2-40B4-BE49-F238E27FC236}">
                <a16:creationId xmlns:a16="http://schemas.microsoft.com/office/drawing/2014/main" id="{A6C24958-4F04-C9A9-0853-1B3018D517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89" t="21640" r="43962" b="27811"/>
          <a:stretch>
            <a:fillRect/>
          </a:stretch>
        </p:blipFill>
        <p:spPr>
          <a:xfrm flipH="1">
            <a:off x="10245094" y="4150232"/>
            <a:ext cx="1526186" cy="19808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1DB3C881-8681-2693-39D8-D317738B67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7" t="30106" r="44321" b="24858"/>
          <a:stretch>
            <a:fillRect/>
          </a:stretch>
        </p:blipFill>
        <p:spPr>
          <a:xfrm>
            <a:off x="6928737" y="4155599"/>
            <a:ext cx="1800449" cy="1991319"/>
          </a:xfrm>
          <a:custGeom>
            <a:avLst/>
            <a:gdLst>
              <a:gd name="connsiteX0" fmla="*/ 0 w 1990800"/>
              <a:gd name="connsiteY0" fmla="*/ 0 h 403200"/>
              <a:gd name="connsiteX1" fmla="*/ 1990800 w 1990800"/>
              <a:gd name="connsiteY1" fmla="*/ 0 h 403200"/>
              <a:gd name="connsiteX2" fmla="*/ 1990800 w 1990800"/>
              <a:gd name="connsiteY2" fmla="*/ 403200 h 403200"/>
              <a:gd name="connsiteX3" fmla="*/ 0 w 1990800"/>
              <a:gd name="connsiteY3" fmla="*/ 403200 h 403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90800" h="403200">
                <a:moveTo>
                  <a:pt x="0" y="0"/>
                </a:moveTo>
                <a:lnTo>
                  <a:pt x="1990800" y="0"/>
                </a:lnTo>
                <a:lnTo>
                  <a:pt x="1990800" y="403200"/>
                </a:lnTo>
                <a:lnTo>
                  <a:pt x="0" y="403200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5606EBCD-F5AF-779F-DF6F-D3F9951F939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05" t="23267" r="44119" b="33774"/>
          <a:stretch>
            <a:fillRect/>
          </a:stretch>
        </p:blipFill>
        <p:spPr>
          <a:xfrm>
            <a:off x="3783430" y="4192129"/>
            <a:ext cx="1980283" cy="1974101"/>
          </a:xfrm>
          <a:custGeom>
            <a:avLst/>
            <a:gdLst>
              <a:gd name="connsiteX0" fmla="*/ 0 w 1990800"/>
              <a:gd name="connsiteY0" fmla="*/ 0 h 403200"/>
              <a:gd name="connsiteX1" fmla="*/ 1990800 w 1990800"/>
              <a:gd name="connsiteY1" fmla="*/ 0 h 403200"/>
              <a:gd name="connsiteX2" fmla="*/ 1990800 w 1990800"/>
              <a:gd name="connsiteY2" fmla="*/ 403200 h 403200"/>
              <a:gd name="connsiteX3" fmla="*/ 0 w 1990800"/>
              <a:gd name="connsiteY3" fmla="*/ 403200 h 403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90800" h="403200">
                <a:moveTo>
                  <a:pt x="0" y="0"/>
                </a:moveTo>
                <a:lnTo>
                  <a:pt x="1990800" y="0"/>
                </a:lnTo>
                <a:lnTo>
                  <a:pt x="1990800" y="403200"/>
                </a:lnTo>
                <a:lnTo>
                  <a:pt x="0" y="403200"/>
                </a:lnTo>
                <a:close/>
              </a:path>
            </a:pathLst>
          </a:custGeom>
          <a:ln w="19050"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B4D6157C-9792-D28D-DCDB-9009A8F6585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25" t="18459" r="45239" b="41688"/>
          <a:stretch>
            <a:fillRect/>
          </a:stretch>
        </p:blipFill>
        <p:spPr>
          <a:xfrm flipH="1">
            <a:off x="652797" y="4168242"/>
            <a:ext cx="2064308" cy="1974101"/>
          </a:xfrm>
          <a:custGeom>
            <a:avLst/>
            <a:gdLst>
              <a:gd name="connsiteX0" fmla="*/ 1990800 w 1990800"/>
              <a:gd name="connsiteY0" fmla="*/ 0 h 403200"/>
              <a:gd name="connsiteX1" fmla="*/ 0 w 1990800"/>
              <a:gd name="connsiteY1" fmla="*/ 0 h 403200"/>
              <a:gd name="connsiteX2" fmla="*/ 0 w 1990800"/>
              <a:gd name="connsiteY2" fmla="*/ 403200 h 403200"/>
              <a:gd name="connsiteX3" fmla="*/ 1990800 w 1990800"/>
              <a:gd name="connsiteY3" fmla="*/ 403200 h 403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90800" h="403200">
                <a:moveTo>
                  <a:pt x="1990800" y="0"/>
                </a:moveTo>
                <a:lnTo>
                  <a:pt x="0" y="0"/>
                </a:lnTo>
                <a:lnTo>
                  <a:pt x="0" y="403200"/>
                </a:lnTo>
                <a:lnTo>
                  <a:pt x="1990800" y="403200"/>
                </a:lnTo>
                <a:close/>
              </a:path>
            </a:pathLst>
          </a:custGeom>
          <a:ln w="19050">
            <a:solidFill>
              <a:schemeClr val="tx1"/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DDEBBC6-C095-C978-EC0C-C4F4F4BB0FE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1" t="23166" r="31306" b="18808"/>
          <a:stretch>
            <a:fillRect/>
          </a:stretch>
        </p:blipFill>
        <p:spPr>
          <a:xfrm>
            <a:off x="618548" y="986862"/>
            <a:ext cx="1853729" cy="1875119"/>
          </a:xfrm>
          <a:custGeom>
            <a:avLst/>
            <a:gdLst>
              <a:gd name="connsiteX0" fmla="*/ 0 w 1988829"/>
              <a:gd name="connsiteY0" fmla="*/ 0 h 403964"/>
              <a:gd name="connsiteX1" fmla="*/ 1988829 w 1988829"/>
              <a:gd name="connsiteY1" fmla="*/ 0 h 403964"/>
              <a:gd name="connsiteX2" fmla="*/ 1988829 w 1988829"/>
              <a:gd name="connsiteY2" fmla="*/ 403964 h 403964"/>
              <a:gd name="connsiteX3" fmla="*/ 0 w 1988829"/>
              <a:gd name="connsiteY3" fmla="*/ 403964 h 40396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88829" h="403964">
                <a:moveTo>
                  <a:pt x="0" y="0"/>
                </a:moveTo>
                <a:lnTo>
                  <a:pt x="1988829" y="0"/>
                </a:lnTo>
                <a:lnTo>
                  <a:pt x="1988829" y="403964"/>
                </a:lnTo>
                <a:lnTo>
                  <a:pt x="0" y="403964"/>
                </a:lnTo>
                <a:close/>
              </a:path>
            </a:pathLst>
          </a:custGeom>
          <a:ln w="19050">
            <a:solidFill>
              <a:schemeClr val="tx1"/>
            </a:solidFill>
          </a:ln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4B477B9B-927F-E861-519F-6CE1300FA908}"/>
              </a:ext>
            </a:extLst>
          </p:cNvPr>
          <p:cNvSpPr/>
          <p:nvPr/>
        </p:nvSpPr>
        <p:spPr>
          <a:xfrm>
            <a:off x="555232" y="2265483"/>
            <a:ext cx="1587376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1F9459F-CDDF-798B-E6AB-048DB027DB23}"/>
              </a:ext>
            </a:extLst>
          </p:cNvPr>
          <p:cNvSpPr txBox="1"/>
          <p:nvPr/>
        </p:nvSpPr>
        <p:spPr>
          <a:xfrm>
            <a:off x="2466403" y="248749"/>
            <a:ext cx="1333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SV-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1982176-C10D-4FBE-345B-0BB9EFDA7D8C}"/>
              </a:ext>
            </a:extLst>
          </p:cNvPr>
          <p:cNvSpPr txBox="1"/>
          <p:nvPr/>
        </p:nvSpPr>
        <p:spPr>
          <a:xfrm>
            <a:off x="-146067" y="2259629"/>
            <a:ext cx="68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F6F6242B-A435-9249-2BC4-9F54926B131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70" t="24320" r="32412" b="16677"/>
          <a:stretch>
            <a:fillRect/>
          </a:stretch>
        </p:blipFill>
        <p:spPr>
          <a:xfrm>
            <a:off x="3756838" y="986862"/>
            <a:ext cx="1922211" cy="1910804"/>
          </a:xfrm>
          <a:custGeom>
            <a:avLst/>
            <a:gdLst>
              <a:gd name="connsiteX0" fmla="*/ 0 w 1988829"/>
              <a:gd name="connsiteY0" fmla="*/ 0 h 403031"/>
              <a:gd name="connsiteX1" fmla="*/ 1988829 w 1988829"/>
              <a:gd name="connsiteY1" fmla="*/ 0 h 403031"/>
              <a:gd name="connsiteX2" fmla="*/ 1988829 w 1988829"/>
              <a:gd name="connsiteY2" fmla="*/ 403031 h 403031"/>
              <a:gd name="connsiteX3" fmla="*/ 0 w 1988829"/>
              <a:gd name="connsiteY3" fmla="*/ 403031 h 4030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88829" h="403031">
                <a:moveTo>
                  <a:pt x="0" y="0"/>
                </a:moveTo>
                <a:lnTo>
                  <a:pt x="1988829" y="0"/>
                </a:lnTo>
                <a:lnTo>
                  <a:pt x="1988829" y="403031"/>
                </a:lnTo>
                <a:lnTo>
                  <a:pt x="0" y="403031"/>
                </a:lnTo>
                <a:close/>
              </a:path>
            </a:pathLst>
          </a:custGeom>
          <a:ln w="19050">
            <a:solidFill>
              <a:schemeClr val="tx1"/>
            </a:solidFill>
          </a:ln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DE5168DA-4153-EA85-B55A-9EB573FF198A}"/>
              </a:ext>
            </a:extLst>
          </p:cNvPr>
          <p:cNvSpPr/>
          <p:nvPr/>
        </p:nvSpPr>
        <p:spPr>
          <a:xfrm>
            <a:off x="3667530" y="1817190"/>
            <a:ext cx="1564448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D862C46-21B3-069D-3F47-F622D11321D2}"/>
              </a:ext>
            </a:extLst>
          </p:cNvPr>
          <p:cNvSpPr txBox="1"/>
          <p:nvPr/>
        </p:nvSpPr>
        <p:spPr>
          <a:xfrm>
            <a:off x="2466403" y="1990149"/>
            <a:ext cx="126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C37D9D9E-DAE7-2499-97C4-8AD42F9301F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37" t="18194" r="27415" b="23734"/>
          <a:stretch>
            <a:fillRect/>
          </a:stretch>
        </p:blipFill>
        <p:spPr>
          <a:xfrm>
            <a:off x="6655570" y="951178"/>
            <a:ext cx="1978068" cy="1914128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842C304C-B131-63A8-0F8B-A0D69666ED26}"/>
              </a:ext>
            </a:extLst>
          </p:cNvPr>
          <p:cNvSpPr/>
          <p:nvPr/>
        </p:nvSpPr>
        <p:spPr>
          <a:xfrm>
            <a:off x="6616766" y="2150894"/>
            <a:ext cx="1563216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D600C16-D14C-DF37-EB0E-A09898F00C3B}"/>
              </a:ext>
            </a:extLst>
          </p:cNvPr>
          <p:cNvSpPr txBox="1"/>
          <p:nvPr/>
        </p:nvSpPr>
        <p:spPr>
          <a:xfrm>
            <a:off x="6021754" y="2140025"/>
            <a:ext cx="68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7E5A1E98-0C6F-F069-7C74-2EAB87C8AEA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22" t="21007" r="29596" b="20178"/>
          <a:stretch>
            <a:fillRect/>
          </a:stretch>
        </p:blipFill>
        <p:spPr>
          <a:xfrm>
            <a:off x="9890122" y="951177"/>
            <a:ext cx="1869899" cy="1910804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ACE15F7C-995F-6456-9392-64DB66370450}"/>
              </a:ext>
            </a:extLst>
          </p:cNvPr>
          <p:cNvSpPr txBox="1"/>
          <p:nvPr/>
        </p:nvSpPr>
        <p:spPr>
          <a:xfrm>
            <a:off x="8574037" y="1721913"/>
            <a:ext cx="126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6E7149AB-7AB7-1D80-852E-92D853A58D3E}"/>
              </a:ext>
            </a:extLst>
          </p:cNvPr>
          <p:cNvSpPr/>
          <p:nvPr/>
        </p:nvSpPr>
        <p:spPr>
          <a:xfrm>
            <a:off x="9810305" y="1661542"/>
            <a:ext cx="1541947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97F4563-E208-16CD-EC82-300A359DE37A}"/>
              </a:ext>
            </a:extLst>
          </p:cNvPr>
          <p:cNvSpPr txBox="1"/>
          <p:nvPr/>
        </p:nvSpPr>
        <p:spPr>
          <a:xfrm>
            <a:off x="8600776" y="269012"/>
            <a:ext cx="1333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ACV-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DCA2874-D9DF-810F-A359-F6F38F46EFD2}"/>
              </a:ext>
            </a:extLst>
          </p:cNvPr>
          <p:cNvSpPr txBox="1"/>
          <p:nvPr/>
        </p:nvSpPr>
        <p:spPr>
          <a:xfrm>
            <a:off x="-58765" y="5679411"/>
            <a:ext cx="68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CB6F5AC-5179-3D10-410F-D157D8091BD9}"/>
              </a:ext>
            </a:extLst>
          </p:cNvPr>
          <p:cNvSpPr/>
          <p:nvPr/>
        </p:nvSpPr>
        <p:spPr>
          <a:xfrm>
            <a:off x="609352" y="5658170"/>
            <a:ext cx="1682225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5757EE9-6875-9B8F-A50E-239AB3973489}"/>
              </a:ext>
            </a:extLst>
          </p:cNvPr>
          <p:cNvSpPr txBox="1"/>
          <p:nvPr/>
        </p:nvSpPr>
        <p:spPr>
          <a:xfrm>
            <a:off x="2599574" y="5562652"/>
            <a:ext cx="126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690DE68E-BBB5-2AD1-5096-098156B82950}"/>
              </a:ext>
            </a:extLst>
          </p:cNvPr>
          <p:cNvSpPr/>
          <p:nvPr/>
        </p:nvSpPr>
        <p:spPr>
          <a:xfrm>
            <a:off x="3667531" y="5568506"/>
            <a:ext cx="1706728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6FE7AB9-FD4F-B26A-893D-9907DE7A21E1}"/>
              </a:ext>
            </a:extLst>
          </p:cNvPr>
          <p:cNvSpPr txBox="1"/>
          <p:nvPr/>
        </p:nvSpPr>
        <p:spPr>
          <a:xfrm>
            <a:off x="2522791" y="3449666"/>
            <a:ext cx="1333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VSV-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F06D1729-5596-BE32-D7B5-43D4953DF22B}"/>
              </a:ext>
            </a:extLst>
          </p:cNvPr>
          <p:cNvSpPr/>
          <p:nvPr/>
        </p:nvSpPr>
        <p:spPr>
          <a:xfrm>
            <a:off x="6847253" y="5552917"/>
            <a:ext cx="1587242" cy="31900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C69FCF4-6D02-887F-98F2-3ECD8D006C99}"/>
              </a:ext>
            </a:extLst>
          </p:cNvPr>
          <p:cNvSpPr txBox="1"/>
          <p:nvPr/>
        </p:nvSpPr>
        <p:spPr>
          <a:xfrm>
            <a:off x="6152080" y="5548673"/>
            <a:ext cx="689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61553F1-F56A-5E5D-A04C-3316041C7A3F}"/>
              </a:ext>
            </a:extLst>
          </p:cNvPr>
          <p:cNvSpPr txBox="1"/>
          <p:nvPr/>
        </p:nvSpPr>
        <p:spPr>
          <a:xfrm>
            <a:off x="8977577" y="5332712"/>
            <a:ext cx="1267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CED0A18E-86F1-8ABC-2520-7BC268BA597A}"/>
              </a:ext>
            </a:extLst>
          </p:cNvPr>
          <p:cNvSpPr/>
          <p:nvPr/>
        </p:nvSpPr>
        <p:spPr>
          <a:xfrm>
            <a:off x="10128363" y="5354794"/>
            <a:ext cx="1347357" cy="35762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68A9518-BC64-4344-8625-6B133538C14D}"/>
              </a:ext>
            </a:extLst>
          </p:cNvPr>
          <p:cNvSpPr txBox="1"/>
          <p:nvPr/>
        </p:nvSpPr>
        <p:spPr>
          <a:xfrm>
            <a:off x="8629928" y="3443984"/>
            <a:ext cx="1333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NDV-GF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133F5E0-252E-68B3-D504-58172080220E}"/>
              </a:ext>
            </a:extLst>
          </p:cNvPr>
          <p:cNvSpPr txBox="1"/>
          <p:nvPr/>
        </p:nvSpPr>
        <p:spPr>
          <a:xfrm>
            <a:off x="583952" y="709863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 80  90 100</a:t>
            </a:r>
            <a:endParaRPr lang="zh-CN" altLang="en-US" sz="12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54B047E-EED3-87DA-C87B-4661830A05AC}"/>
              </a:ext>
            </a:extLst>
          </p:cNvPr>
          <p:cNvSpPr txBox="1"/>
          <p:nvPr/>
        </p:nvSpPr>
        <p:spPr>
          <a:xfrm>
            <a:off x="-4934" y="709862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D6E7129-4E97-8E6D-98AA-3F85F3917D94}"/>
              </a:ext>
            </a:extLst>
          </p:cNvPr>
          <p:cNvSpPr txBox="1"/>
          <p:nvPr/>
        </p:nvSpPr>
        <p:spPr>
          <a:xfrm>
            <a:off x="3773737" y="715657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 80  90 100</a:t>
            </a:r>
            <a:endParaRPr lang="zh-CN" altLang="en-US" sz="12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3A25EC4-3587-EA1F-5D4F-0ED80D46D637}"/>
              </a:ext>
            </a:extLst>
          </p:cNvPr>
          <p:cNvSpPr txBox="1"/>
          <p:nvPr/>
        </p:nvSpPr>
        <p:spPr>
          <a:xfrm>
            <a:off x="3184851" y="715656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9AB6620-EB3E-EECB-20D7-4B1B90D7BD49}"/>
              </a:ext>
            </a:extLst>
          </p:cNvPr>
          <p:cNvSpPr txBox="1"/>
          <p:nvPr/>
        </p:nvSpPr>
        <p:spPr>
          <a:xfrm>
            <a:off x="6633655" y="692181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 80  90 100</a:t>
            </a:r>
            <a:endParaRPr lang="zh-CN" altLang="en-US" sz="12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4336F52-3590-B383-7840-935E3177622D}"/>
              </a:ext>
            </a:extLst>
          </p:cNvPr>
          <p:cNvSpPr txBox="1"/>
          <p:nvPr/>
        </p:nvSpPr>
        <p:spPr>
          <a:xfrm>
            <a:off x="6044769" y="692180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CCB6158-118F-6C4B-433F-6EB4E00EF7AE}"/>
              </a:ext>
            </a:extLst>
          </p:cNvPr>
          <p:cNvSpPr txBox="1"/>
          <p:nvPr/>
        </p:nvSpPr>
        <p:spPr>
          <a:xfrm>
            <a:off x="9855817" y="692182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 80  90 100</a:t>
            </a:r>
            <a:endParaRPr lang="zh-CN" altLang="en-US" sz="12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E1DC594-7F75-6916-E852-BC6E9B3E9020}"/>
              </a:ext>
            </a:extLst>
          </p:cNvPr>
          <p:cNvSpPr txBox="1"/>
          <p:nvPr/>
        </p:nvSpPr>
        <p:spPr>
          <a:xfrm>
            <a:off x="9266931" y="692181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03FCDE44-8E72-7397-A0E9-826658FD3EB2}"/>
              </a:ext>
            </a:extLst>
          </p:cNvPr>
          <p:cNvSpPr txBox="1"/>
          <p:nvPr/>
        </p:nvSpPr>
        <p:spPr>
          <a:xfrm>
            <a:off x="699874" y="3901730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-    70   80   90   100</a:t>
            </a:r>
            <a:endParaRPr lang="zh-CN" altLang="en-US" sz="12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4518826-A3B2-FFA2-AC35-5442F4DFE0CB}"/>
              </a:ext>
            </a:extLst>
          </p:cNvPr>
          <p:cNvSpPr txBox="1"/>
          <p:nvPr/>
        </p:nvSpPr>
        <p:spPr>
          <a:xfrm>
            <a:off x="110988" y="3901729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5FEBC66-CBF9-E7D7-4BBD-54A29334B714}"/>
              </a:ext>
            </a:extLst>
          </p:cNvPr>
          <p:cNvSpPr txBox="1"/>
          <p:nvPr/>
        </p:nvSpPr>
        <p:spPr>
          <a:xfrm>
            <a:off x="3841638" y="3901729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80   90  100</a:t>
            </a:r>
            <a:endParaRPr lang="zh-CN" altLang="en-US" sz="12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3AFC6D4-2DF1-510F-2710-9EEEAB6E5DA4}"/>
              </a:ext>
            </a:extLst>
          </p:cNvPr>
          <p:cNvSpPr txBox="1"/>
          <p:nvPr/>
        </p:nvSpPr>
        <p:spPr>
          <a:xfrm>
            <a:off x="3210872" y="3901728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3F67BBB-3EB6-95F3-68D0-32819EC1E453}"/>
              </a:ext>
            </a:extLst>
          </p:cNvPr>
          <p:cNvSpPr txBox="1"/>
          <p:nvPr/>
        </p:nvSpPr>
        <p:spPr>
          <a:xfrm>
            <a:off x="6950936" y="3890531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 80  90  100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12254C2-6235-4AB4-F9D5-D325B34DE6E8}"/>
              </a:ext>
            </a:extLst>
          </p:cNvPr>
          <p:cNvSpPr txBox="1"/>
          <p:nvPr/>
        </p:nvSpPr>
        <p:spPr>
          <a:xfrm>
            <a:off x="6122708" y="3890530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40FC951-59E6-BA8A-2661-21496BE1E5B8}"/>
              </a:ext>
            </a:extLst>
          </p:cNvPr>
          <p:cNvSpPr txBox="1"/>
          <p:nvPr/>
        </p:nvSpPr>
        <p:spPr>
          <a:xfrm>
            <a:off x="10110899" y="3895610"/>
            <a:ext cx="1673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  -   70  80  90 100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E2CBC7D-832C-8AB7-E617-77DF09F9CC93}"/>
              </a:ext>
            </a:extLst>
          </p:cNvPr>
          <p:cNvSpPr txBox="1"/>
          <p:nvPr/>
        </p:nvSpPr>
        <p:spPr>
          <a:xfrm>
            <a:off x="9282671" y="3895609"/>
            <a:ext cx="7766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T (</a:t>
            </a:r>
            <a:r>
              <a:rPr lang="en-US" altLang="zh-CN" sz="1200" dirty="0" err="1"/>
              <a:t>μM</a:t>
            </a:r>
            <a:r>
              <a:rPr lang="en-US" altLang="zh-CN" sz="1200" dirty="0"/>
              <a:t>)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484605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94</Words>
  <Application>Microsoft Office PowerPoint</Application>
  <PresentationFormat>宽屏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4</cp:revision>
  <dcterms:created xsi:type="dcterms:W3CDTF">2025-07-10T12:41:30Z</dcterms:created>
  <dcterms:modified xsi:type="dcterms:W3CDTF">2025-09-12T06:26:47Z</dcterms:modified>
</cp:coreProperties>
</file>